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5" r:id="rId2"/>
  </p:sldIdLst>
  <p:sldSz cx="6858000" cy="9906000" type="A4"/>
  <p:notesSz cx="9144000" cy="6858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303" autoAdjust="0"/>
    <p:restoredTop sz="94660"/>
  </p:normalViewPr>
  <p:slideViewPr>
    <p:cSldViewPr snapToGrid="0">
      <p:cViewPr varScale="1">
        <p:scale>
          <a:sx n="45" d="100"/>
          <a:sy n="45" d="100"/>
        </p:scale>
        <p:origin x="2073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E2780B-98F6-4E89-8D21-E2BC8715C1FD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E9BDBB-BAB9-462E-BB64-097690E3DC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6664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86833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36868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68587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55043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09626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4667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0988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1304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3023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9769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77059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4889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5" Type="http://schemas.openxmlformats.org/officeDocument/2006/relationships/image" Target="../media/image24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24" Type="http://schemas.openxmlformats.org/officeDocument/2006/relationships/image" Target="../media/image23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openxmlformats.org/officeDocument/2006/relationships/image" Target="../media/image22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 txBox="1">
            <a:spLocks/>
          </p:cNvSpPr>
          <p:nvPr/>
        </p:nvSpPr>
        <p:spPr>
          <a:xfrm>
            <a:off x="116632" y="128464"/>
            <a:ext cx="3037502" cy="367550"/>
          </a:xfrm>
          <a:prstGeom prst="rect">
            <a:avLst/>
          </a:prstGeom>
        </p:spPr>
        <p:txBody>
          <a:bodyPr vert="horz" lIns="68580" tIns="34290" rIns="68580" bIns="3429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zh-CN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 4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794803" y="854101"/>
            <a:ext cx="318037" cy="392415"/>
          </a:xfrm>
          <a:prstGeom prst="rect">
            <a:avLst/>
          </a:prstGeom>
          <a:noFill/>
        </p:spPr>
        <p:txBody>
          <a:bodyPr wrap="none" lIns="68580" tIns="34290" rIns="68580" bIns="34290">
            <a:spAutoFit/>
          </a:bodyPr>
          <a:lstStyle/>
          <a:p>
            <a:pPr algn="ctr"/>
            <a:r>
              <a:rPr lang="en-US" altLang="zh-CN" sz="2100" dirty="0" smtClean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100" dirty="0">
              <a:ln w="0"/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4"/>
          <p:cNvSpPr txBox="1"/>
          <p:nvPr/>
        </p:nvSpPr>
        <p:spPr>
          <a:xfrm>
            <a:off x="4766750" y="4144862"/>
            <a:ext cx="9790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orafenib</a:t>
            </a:r>
          </a:p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</a:p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SC-J9 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645271" y="4144862"/>
            <a:ext cx="9299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orafenib</a:t>
            </a:r>
          </a:p>
        </p:txBody>
      </p:sp>
      <p:sp>
        <p:nvSpPr>
          <p:cNvPr id="8" name="矩形 7"/>
          <p:cNvSpPr/>
          <p:nvPr/>
        </p:nvSpPr>
        <p:spPr>
          <a:xfrm>
            <a:off x="1766150" y="4144862"/>
            <a:ext cx="49705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3776202" y="4144862"/>
            <a:ext cx="820356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SC-J9 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794803" y="1883881"/>
            <a:ext cx="65399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877671" y="2706252"/>
            <a:ext cx="571122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UNEL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897255" y="3581972"/>
            <a:ext cx="551538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2650437" y="1274685"/>
            <a:ext cx="170878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UNEL assay on HA22T</a:t>
            </a:r>
          </a:p>
        </p:txBody>
      </p:sp>
      <p:sp>
        <p:nvSpPr>
          <p:cNvPr id="14" name="TextBox 4"/>
          <p:cNvSpPr txBox="1"/>
          <p:nvPr/>
        </p:nvSpPr>
        <p:spPr>
          <a:xfrm>
            <a:off x="4817549" y="8286344"/>
            <a:ext cx="9282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orafenib</a:t>
            </a:r>
          </a:p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</a:p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SC-J9 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6"/>
          <p:cNvSpPr txBox="1"/>
          <p:nvPr/>
        </p:nvSpPr>
        <p:spPr>
          <a:xfrm>
            <a:off x="2594521" y="8286344"/>
            <a:ext cx="9299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orafenib</a:t>
            </a:r>
          </a:p>
        </p:txBody>
      </p:sp>
      <p:sp>
        <p:nvSpPr>
          <p:cNvPr id="16" name="矩形 15"/>
          <p:cNvSpPr/>
          <p:nvPr/>
        </p:nvSpPr>
        <p:spPr>
          <a:xfrm>
            <a:off x="1715400" y="8286344"/>
            <a:ext cx="49705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3725452" y="8286344"/>
            <a:ext cx="820356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zh-CN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SC-J9 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/>
          <p:cNvSpPr/>
          <p:nvPr/>
        </p:nvSpPr>
        <p:spPr>
          <a:xfrm>
            <a:off x="821105" y="6076581"/>
            <a:ext cx="65399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821105" y="6898952"/>
            <a:ext cx="65399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UNEL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923557" y="7723454"/>
            <a:ext cx="551538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2670122" y="5439188"/>
            <a:ext cx="170878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UNEL assay on SKhep1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/>
          <p:cNvSpPr/>
          <p:nvPr/>
        </p:nvSpPr>
        <p:spPr>
          <a:xfrm>
            <a:off x="794803" y="5087832"/>
            <a:ext cx="318036" cy="392415"/>
          </a:xfrm>
          <a:prstGeom prst="rect">
            <a:avLst/>
          </a:prstGeom>
          <a:noFill/>
        </p:spPr>
        <p:txBody>
          <a:bodyPr wrap="none" lIns="68580" tIns="34290" rIns="68580" bIns="34290">
            <a:spAutoFit/>
          </a:bodyPr>
          <a:lstStyle/>
          <a:p>
            <a:pPr algn="ctr"/>
            <a:r>
              <a:rPr lang="en-US" altLang="zh-CN" sz="2100" dirty="0" smtClean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100" dirty="0">
              <a:ln w="0"/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组合 24"/>
          <p:cNvGrpSpPr/>
          <p:nvPr/>
        </p:nvGrpSpPr>
        <p:grpSpPr>
          <a:xfrm>
            <a:off x="1519492" y="1614414"/>
            <a:ext cx="4226284" cy="2462740"/>
            <a:chOff x="1142976" y="1575874"/>
            <a:chExt cx="7786742" cy="4537489"/>
          </a:xfrm>
        </p:grpSpPr>
        <p:pic>
          <p:nvPicPr>
            <p:cNvPr id="26" name="Picture 2" descr="E:\360云盘\文档\学术\研究生研究\性激素与肝癌\Data\TUNEL\2014-12-22 TUNEL HA22T S+J\Publish\HA22T 0J0S Hoechst 3.ti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142976" y="1575874"/>
              <a:ext cx="1785950" cy="1344715"/>
            </a:xfrm>
            <a:prstGeom prst="rect">
              <a:avLst/>
            </a:prstGeom>
            <a:noFill/>
          </p:spPr>
        </p:pic>
        <p:pic>
          <p:nvPicPr>
            <p:cNvPr id="27" name="Picture 3" descr="E:\360云盘\文档\学术\研究生研究\性激素与肝癌\Data\TUNEL\2014-12-22 TUNEL HA22T S+J\Publish\HA22T 0J0S Merged 3.tif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142976" y="4768648"/>
              <a:ext cx="1785950" cy="1344715"/>
            </a:xfrm>
            <a:prstGeom prst="rect">
              <a:avLst/>
            </a:prstGeom>
            <a:noFill/>
          </p:spPr>
        </p:pic>
        <p:pic>
          <p:nvPicPr>
            <p:cNvPr id="28" name="Picture 4" descr="E:\360云盘\文档\学术\研究生研究\性激素与肝癌\Data\TUNEL\2014-12-22 TUNEL HA22T S+J\Publish\HA22T 0J0S TUNEL 3.tif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142976" y="3143248"/>
              <a:ext cx="1785950" cy="1344715"/>
            </a:xfrm>
            <a:prstGeom prst="rect">
              <a:avLst/>
            </a:prstGeom>
            <a:noFill/>
          </p:spPr>
        </p:pic>
        <p:pic>
          <p:nvPicPr>
            <p:cNvPr id="29" name="Picture 5" descr="E:\360云盘\文档\学术\研究生研究\性激素与肝癌\Data\TUNEL\2014-12-22 TUNEL HA22T S+J\Publish\HA22T 0J5S Hoechst 2.tif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143240" y="1584219"/>
              <a:ext cx="1785950" cy="1344715"/>
            </a:xfrm>
            <a:prstGeom prst="rect">
              <a:avLst/>
            </a:prstGeom>
            <a:noFill/>
          </p:spPr>
        </p:pic>
        <p:pic>
          <p:nvPicPr>
            <p:cNvPr id="30" name="Picture 6" descr="E:\360云盘\文档\学术\研究生研究\性激素与肝癌\Data\TUNEL\2014-12-22 TUNEL HA22T S+J\Publish\HA22T 0J5S Merged 2.tif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3143240" y="4768648"/>
              <a:ext cx="1785950" cy="1344715"/>
            </a:xfrm>
            <a:prstGeom prst="rect">
              <a:avLst/>
            </a:prstGeom>
            <a:noFill/>
          </p:spPr>
        </p:pic>
        <p:pic>
          <p:nvPicPr>
            <p:cNvPr id="31" name="Picture 7" descr="E:\360云盘\文档\学术\研究生研究\性激素与肝癌\Data\TUNEL\2014-12-22 TUNEL HA22T S+J\Publish\HA22T 0J5S TUNEL 2.tif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3143240" y="3143248"/>
              <a:ext cx="1785950" cy="1344715"/>
            </a:xfrm>
            <a:prstGeom prst="rect">
              <a:avLst/>
            </a:prstGeom>
            <a:noFill/>
          </p:spPr>
        </p:pic>
        <p:pic>
          <p:nvPicPr>
            <p:cNvPr id="32" name="Picture 8" descr="E:\360云盘\文档\学术\研究生研究\性激素与肝癌\Data\TUNEL\2014-12-22 TUNEL HA22T S+J\Publish\HA22T 5J0S Hoechst 1.tif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5143504" y="1584219"/>
              <a:ext cx="1785950" cy="1344715"/>
            </a:xfrm>
            <a:prstGeom prst="rect">
              <a:avLst/>
            </a:prstGeom>
            <a:noFill/>
          </p:spPr>
        </p:pic>
        <p:pic>
          <p:nvPicPr>
            <p:cNvPr id="33" name="Picture 9" descr="E:\360云盘\文档\学术\研究生研究\性激素与肝癌\Data\TUNEL\2014-12-22 TUNEL HA22T S+J\Publish\HA22T 5J0S Merged 1.tif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5143504" y="4768648"/>
              <a:ext cx="1785950" cy="1344715"/>
            </a:xfrm>
            <a:prstGeom prst="rect">
              <a:avLst/>
            </a:prstGeom>
            <a:noFill/>
          </p:spPr>
        </p:pic>
        <p:pic>
          <p:nvPicPr>
            <p:cNvPr id="34" name="Picture 10" descr="E:\360云盘\文档\学术\研究生研究\性激素与肝癌\Data\TUNEL\2014-12-22 TUNEL HA22T S+J\Publish\HA22T 5J0S TUNEL 1.tif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5143504" y="3143248"/>
              <a:ext cx="1785950" cy="1344715"/>
            </a:xfrm>
            <a:prstGeom prst="rect">
              <a:avLst/>
            </a:prstGeom>
            <a:noFill/>
          </p:spPr>
        </p:pic>
        <p:pic>
          <p:nvPicPr>
            <p:cNvPr id="35" name="Picture 11" descr="E:\360云盘\文档\学术\研究生研究\性激素与肝癌\Data\TUNEL\2014-12-22 TUNEL HA22T S+J\Publish\HA22T 5J5S Hoechst 5.tif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7143768" y="1584219"/>
              <a:ext cx="1785950" cy="1344715"/>
            </a:xfrm>
            <a:prstGeom prst="rect">
              <a:avLst/>
            </a:prstGeom>
            <a:noFill/>
          </p:spPr>
        </p:pic>
        <p:pic>
          <p:nvPicPr>
            <p:cNvPr id="36" name="Picture 12" descr="E:\360云盘\文档\学术\研究生研究\性激素与肝癌\Data\TUNEL\2014-12-22 TUNEL HA22T S+J\Publish\HA22T 5J5S Merged 5.tif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7143768" y="4768648"/>
              <a:ext cx="1785950" cy="1344715"/>
            </a:xfrm>
            <a:prstGeom prst="rect">
              <a:avLst/>
            </a:prstGeom>
            <a:noFill/>
          </p:spPr>
        </p:pic>
        <p:pic>
          <p:nvPicPr>
            <p:cNvPr id="37" name="Picture 13" descr="E:\360云盘\文档\学术\研究生研究\性激素与肝癌\Data\TUNEL\2014-12-22 TUNEL HA22T S+J\Publish\HA22T 5J5S TUNEL 5.tif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7143768" y="3143248"/>
              <a:ext cx="1785950" cy="1344715"/>
            </a:xfrm>
            <a:prstGeom prst="rect">
              <a:avLst/>
            </a:prstGeom>
            <a:noFill/>
          </p:spPr>
        </p:pic>
      </p:grpSp>
      <p:grpSp>
        <p:nvGrpSpPr>
          <p:cNvPr id="38" name="组合 37"/>
          <p:cNvGrpSpPr/>
          <p:nvPr/>
        </p:nvGrpSpPr>
        <p:grpSpPr>
          <a:xfrm>
            <a:off x="1521556" y="5816977"/>
            <a:ext cx="4224220" cy="2438590"/>
            <a:chOff x="1126233" y="1579932"/>
            <a:chExt cx="7732047" cy="4463614"/>
          </a:xfrm>
        </p:grpSpPr>
        <p:pic>
          <p:nvPicPr>
            <p:cNvPr id="39" name="Picture 2" descr="E:\360云盘\文档\学术\研究生研究\性激素与肝癌\Data\TUNEL\2014-12-17 TUNEL SK S+J\Publish\SK 0J0S Merged 4.tif"/>
            <p:cNvPicPr>
              <a:picLocks noChangeAspect="1" noChangeArrowheads="1"/>
            </p:cNvPicPr>
            <p:nvPr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1126233" y="4686224"/>
              <a:ext cx="1785951" cy="1344715"/>
            </a:xfrm>
            <a:prstGeom prst="rect">
              <a:avLst/>
            </a:prstGeom>
            <a:noFill/>
          </p:spPr>
        </p:pic>
        <p:pic>
          <p:nvPicPr>
            <p:cNvPr id="40" name="Picture 3" descr="E:\360云盘\文档\学术\研究生研究\性激素与肝癌\Data\TUNEL\2014-12-17 TUNEL SK S+J\Publish\SK 0J5S Merged 2.tif"/>
            <p:cNvPicPr>
              <a:picLocks noChangeAspect="1" noChangeArrowheads="1"/>
            </p:cNvPicPr>
            <p:nvPr/>
          </p:nvPicPr>
          <p:blipFill>
            <a:blip r:embed="rId15" cstate="print"/>
            <a:srcRect/>
            <a:stretch>
              <a:fillRect/>
            </a:stretch>
          </p:blipFill>
          <p:spPr bwMode="auto">
            <a:xfrm>
              <a:off x="3097104" y="4686224"/>
              <a:ext cx="1785949" cy="1344715"/>
            </a:xfrm>
            <a:prstGeom prst="rect">
              <a:avLst/>
            </a:prstGeom>
            <a:noFill/>
          </p:spPr>
        </p:pic>
        <p:pic>
          <p:nvPicPr>
            <p:cNvPr id="41" name="Picture 4" descr="E:\360云盘\文档\学术\研究生研究\性激素与肝癌\Data\TUNEL\2014-12-17 TUNEL SK S+J\Publish\SK 5J0S Merged 4.tif"/>
            <p:cNvPicPr>
              <a:picLocks noChangeAspect="1" noChangeArrowheads="1"/>
            </p:cNvPicPr>
            <p:nvPr/>
          </p:nvPicPr>
          <p:blipFill>
            <a:blip r:embed="rId16" cstate="print"/>
            <a:srcRect/>
            <a:stretch>
              <a:fillRect/>
            </a:stretch>
          </p:blipFill>
          <p:spPr bwMode="auto">
            <a:xfrm>
              <a:off x="5067973" y="4686224"/>
              <a:ext cx="1802693" cy="1357322"/>
            </a:xfrm>
            <a:prstGeom prst="rect">
              <a:avLst/>
            </a:prstGeom>
            <a:noFill/>
          </p:spPr>
        </p:pic>
        <p:pic>
          <p:nvPicPr>
            <p:cNvPr id="42" name="Picture 5" descr="E:\360云盘\文档\学术\研究生研究\性激素与肝癌\Data\TUNEL\2014-12-17 TUNEL SK S+J\Publish\SK 5J5S Merged 4.tif"/>
            <p:cNvPicPr>
              <a:picLocks noChangeAspect="1" noChangeArrowheads="1"/>
            </p:cNvPicPr>
            <p:nvPr/>
          </p:nvPicPr>
          <p:blipFill>
            <a:blip r:embed="rId17" cstate="print"/>
            <a:srcRect/>
            <a:stretch>
              <a:fillRect/>
            </a:stretch>
          </p:blipFill>
          <p:spPr bwMode="auto">
            <a:xfrm>
              <a:off x="7055587" y="4686224"/>
              <a:ext cx="1802693" cy="1357322"/>
            </a:xfrm>
            <a:prstGeom prst="rect">
              <a:avLst/>
            </a:prstGeom>
            <a:noFill/>
          </p:spPr>
        </p:pic>
        <p:pic>
          <p:nvPicPr>
            <p:cNvPr id="43" name="Picture 6" descr="E:\360云盘\文档\学术\研究生研究\性激素与肝癌\Data\TUNEL\2014-12-17 TUNEL SK S+J\Publish\SK 0J0S Hoechst 4.tif"/>
            <p:cNvPicPr>
              <a:picLocks noChangeAspect="1" noChangeArrowheads="1"/>
            </p:cNvPicPr>
            <p:nvPr/>
          </p:nvPicPr>
          <p:blipFill>
            <a:blip r:embed="rId18" cstate="print"/>
            <a:srcRect/>
            <a:stretch>
              <a:fillRect/>
            </a:stretch>
          </p:blipFill>
          <p:spPr bwMode="auto">
            <a:xfrm>
              <a:off x="1126233" y="1579932"/>
              <a:ext cx="1785950" cy="1344715"/>
            </a:xfrm>
            <a:prstGeom prst="rect">
              <a:avLst/>
            </a:prstGeom>
            <a:noFill/>
          </p:spPr>
        </p:pic>
        <p:pic>
          <p:nvPicPr>
            <p:cNvPr id="44" name="Picture 7" descr="E:\360云盘\文档\学术\研究生研究\性激素与肝癌\Data\TUNEL\2014-12-17 TUNEL SK S+J\Publish\SK 0J0S TUNEL 4.tif"/>
            <p:cNvPicPr>
              <a:picLocks noChangeAspect="1" noChangeArrowheads="1"/>
            </p:cNvPicPr>
            <p:nvPr/>
          </p:nvPicPr>
          <p:blipFill>
            <a:blip r:embed="rId19" cstate="print"/>
            <a:srcRect/>
            <a:stretch>
              <a:fillRect/>
            </a:stretch>
          </p:blipFill>
          <p:spPr bwMode="auto">
            <a:xfrm>
              <a:off x="1126233" y="3114588"/>
              <a:ext cx="1785950" cy="1344715"/>
            </a:xfrm>
            <a:prstGeom prst="rect">
              <a:avLst/>
            </a:prstGeom>
            <a:noFill/>
          </p:spPr>
        </p:pic>
        <p:pic>
          <p:nvPicPr>
            <p:cNvPr id="45" name="Picture 8" descr="E:\360云盘\文档\学术\研究生研究\性激素与肝癌\Data\TUNEL\2014-12-17 TUNEL SK S+J\Publish\SK 0J5S Hoechst 2.tif"/>
            <p:cNvPicPr>
              <a:picLocks noChangeAspect="1" noChangeArrowheads="1"/>
            </p:cNvPicPr>
            <p:nvPr/>
          </p:nvPicPr>
          <p:blipFill>
            <a:blip r:embed="rId20" cstate="print"/>
            <a:srcRect/>
            <a:stretch>
              <a:fillRect/>
            </a:stretch>
          </p:blipFill>
          <p:spPr bwMode="auto">
            <a:xfrm>
              <a:off x="3108265" y="1579932"/>
              <a:ext cx="1785950" cy="1344715"/>
            </a:xfrm>
            <a:prstGeom prst="rect">
              <a:avLst/>
            </a:prstGeom>
            <a:noFill/>
          </p:spPr>
        </p:pic>
        <p:pic>
          <p:nvPicPr>
            <p:cNvPr id="46" name="Picture 9" descr="E:\360云盘\文档\学术\研究生研究\性激素与肝癌\Data\TUNEL\2014-12-17 TUNEL SK S+J\Publish\SK 0J5S TUNEL 2.tif"/>
            <p:cNvPicPr>
              <a:picLocks noChangeAspect="1" noChangeArrowheads="1"/>
            </p:cNvPicPr>
            <p:nvPr/>
          </p:nvPicPr>
          <p:blipFill>
            <a:blip r:embed="rId21" cstate="print"/>
            <a:srcRect/>
            <a:stretch>
              <a:fillRect/>
            </a:stretch>
          </p:blipFill>
          <p:spPr bwMode="auto">
            <a:xfrm>
              <a:off x="3108265" y="3114588"/>
              <a:ext cx="1785950" cy="1344715"/>
            </a:xfrm>
            <a:prstGeom prst="rect">
              <a:avLst/>
            </a:prstGeom>
            <a:noFill/>
          </p:spPr>
        </p:pic>
        <p:pic>
          <p:nvPicPr>
            <p:cNvPr id="47" name="Picture 10" descr="E:\360云盘\文档\学术\研究生研究\性激素与肝癌\Data\TUNEL\2014-12-17 TUNEL SK S+J\Publish\SK 5J0S Hoechst 4.tif"/>
            <p:cNvPicPr>
              <a:picLocks noChangeAspect="1" noChangeArrowheads="1"/>
            </p:cNvPicPr>
            <p:nvPr/>
          </p:nvPicPr>
          <p:blipFill>
            <a:blip r:embed="rId22" cstate="print"/>
            <a:srcRect/>
            <a:stretch>
              <a:fillRect/>
            </a:stretch>
          </p:blipFill>
          <p:spPr bwMode="auto">
            <a:xfrm>
              <a:off x="5090297" y="1579932"/>
              <a:ext cx="1785950" cy="1344715"/>
            </a:xfrm>
            <a:prstGeom prst="rect">
              <a:avLst/>
            </a:prstGeom>
            <a:noFill/>
          </p:spPr>
        </p:pic>
        <p:pic>
          <p:nvPicPr>
            <p:cNvPr id="48" name="Picture 11" descr="E:\360云盘\文档\学术\研究生研究\性激素与肝癌\Data\TUNEL\2014-12-17 TUNEL SK S+J\Publish\SK 5J0S TUNEL 4.tif"/>
            <p:cNvPicPr>
              <a:picLocks noChangeAspect="1" noChangeArrowheads="1"/>
            </p:cNvPicPr>
            <p:nvPr/>
          </p:nvPicPr>
          <p:blipFill>
            <a:blip r:embed="rId23" cstate="print"/>
            <a:srcRect/>
            <a:stretch>
              <a:fillRect/>
            </a:stretch>
          </p:blipFill>
          <p:spPr bwMode="auto">
            <a:xfrm>
              <a:off x="5090297" y="3114588"/>
              <a:ext cx="1785950" cy="1344715"/>
            </a:xfrm>
            <a:prstGeom prst="rect">
              <a:avLst/>
            </a:prstGeom>
            <a:noFill/>
          </p:spPr>
        </p:pic>
        <p:pic>
          <p:nvPicPr>
            <p:cNvPr id="49" name="Picture 12" descr="E:\360云盘\文档\学术\研究生研究\性激素与肝癌\Data\TUNEL\2014-12-17 TUNEL SK S+J\Publish\SK 5J5S Hoechst 4.tif"/>
            <p:cNvPicPr>
              <a:picLocks noChangeAspect="1" noChangeArrowheads="1"/>
            </p:cNvPicPr>
            <p:nvPr/>
          </p:nvPicPr>
          <p:blipFill>
            <a:blip r:embed="rId24" cstate="print"/>
            <a:srcRect/>
            <a:stretch>
              <a:fillRect/>
            </a:stretch>
          </p:blipFill>
          <p:spPr bwMode="auto">
            <a:xfrm>
              <a:off x="7072330" y="1579932"/>
              <a:ext cx="1785950" cy="1344715"/>
            </a:xfrm>
            <a:prstGeom prst="rect">
              <a:avLst/>
            </a:prstGeom>
            <a:noFill/>
          </p:spPr>
        </p:pic>
        <p:pic>
          <p:nvPicPr>
            <p:cNvPr id="50" name="Picture 13" descr="E:\360云盘\文档\学术\研究生研究\性激素与肝癌\Data\TUNEL\2014-12-17 TUNEL SK S+J\Publish\SK 5J5S TUNEL 4.tif"/>
            <p:cNvPicPr>
              <a:picLocks noChangeAspect="1" noChangeArrowheads="1"/>
            </p:cNvPicPr>
            <p:nvPr/>
          </p:nvPicPr>
          <p:blipFill>
            <a:blip r:embed="rId25" cstate="print"/>
            <a:srcRect/>
            <a:stretch>
              <a:fillRect/>
            </a:stretch>
          </p:blipFill>
          <p:spPr bwMode="auto">
            <a:xfrm>
              <a:off x="7072330" y="3114588"/>
              <a:ext cx="1785950" cy="1344715"/>
            </a:xfrm>
            <a:prstGeom prst="rect">
              <a:avLst/>
            </a:prstGeom>
            <a:noFill/>
          </p:spPr>
        </p:pic>
      </p:grpSp>
    </p:spTree>
    <p:extLst>
      <p:ext uri="{BB962C8B-B14F-4D97-AF65-F5344CB8AC3E}">
        <p14:creationId xmlns:p14="http://schemas.microsoft.com/office/powerpoint/2010/main" val="21338897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96</TotalTime>
  <Words>49</Words>
  <Application>Microsoft Office PowerPoint</Application>
  <PresentationFormat>A4 纸张(210x297 毫米)</PresentationFormat>
  <Paragraphs>2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bined therapy of Sorafenib with ASC-J9®synergisticallysuppresses the HCC progression via alteration of pSTAT3-CCL2/Bcl2 signals</dc:title>
  <dc:creator>Junjie Xu</dc:creator>
  <cp:lastModifiedBy>Junjie Xu</cp:lastModifiedBy>
  <cp:revision>102</cp:revision>
  <dcterms:created xsi:type="dcterms:W3CDTF">2015-05-20T05:34:38Z</dcterms:created>
  <dcterms:modified xsi:type="dcterms:W3CDTF">2016-09-23T03:20:18Z</dcterms:modified>
</cp:coreProperties>
</file>